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5" r:id="rId3"/>
    <p:sldId id="269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3" d="100"/>
          <a:sy n="53" d="100"/>
        </p:scale>
        <p:origin x="3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60D5588-4470-48AA-AF78-3A497E60AB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44B32C31-54E9-411E-AE66-9C9E8ECD42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7F07CC3-CCD3-4F11-B73D-7713B09B5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CA964C2-64BE-4492-BFDC-F8FCEB3B4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A06BCE2-3BBE-413A-AED2-687D5F7B30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47507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2228004-98BC-4CE5-8E27-46443E440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59337C7-7D69-4D21-90FF-056784105E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9BB18C-7EE8-46E1-9EED-A3FEDF07A2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446F588-5B75-4878-A37C-D4AD946AE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6ABB20B-8A70-471F-AAD8-BA8294E99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1073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4EF34BE-CCCD-4E6D-8956-986041BC92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4D8AED7-E5EF-4861-96FD-FF05EB6C6F3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BFB520C-2861-43B1-B46D-2B66D0F18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CB760D7-9FEA-45A9-BCCC-14026536FE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4D7CC09-0E91-4F86-9019-938F5F8665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56511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50D5FC7-5B46-40B6-9979-562B4FDBFF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FE1D53C-CB7E-42EC-9BA3-44CC5F96C1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3778882-BCE5-4EE6-8CE5-46B8DC322E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B457F11-7370-43D2-AF1E-41046A39F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763CE2-D4AC-4485-85C2-167669B0A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38545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100AEA-6818-48A5-B385-82EEBD170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DA671BA-5638-4B31-A8C5-0324A84A67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67A8CFB-FA00-4854-A787-AFD08E0F59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55C578E-3F18-42E7-8438-4DC47D5F0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C4624B3-F4AE-4F94-90D4-1033812924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562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FC5BFC-8525-4FB7-8C3E-F8ADC5953BD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D4CD63A-2289-4B6E-87A7-4295198594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9A7C89E-C3AF-4171-8DB8-14A4B9A675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2D1240E-E616-46F2-845A-FC7044B2D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B876D66-8682-46A3-BE75-CD511EB24B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A49276C-6EA5-4F4E-81E0-42348C4C0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44891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9B4AE7A-CD59-40C2-9594-3B1649FAF5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BF24EEA-CBDF-41BC-9E75-6D89C220E6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32D7C87-2360-438D-B07C-DD0180195D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9BE193F-02D9-4306-BDC6-4B038A3F84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501CC64-75C8-4B10-89AB-8134241BDA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B13B66F-B7E4-4D15-BD0A-E264EC9AAC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CD8C2B5-53B9-477C-99D4-A2B3C176D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FEE5F700-D8AA-487D-97EA-78D34417A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96895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D83D93F-CBFD-4520-9C01-B07E1790C5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AD21B929-C84C-462B-9241-48C63C39A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CA2BDCB3-999A-4BB1-8B2A-C632C1B52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CAD5D2E-DAAC-4BEA-87CD-E7534D2A51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3847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62193252-F81D-4D9A-B121-2DD47CA0B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7579217-43FF-4EC1-8B7F-FBCDFCB03D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3A3AE2AB-C4D4-475B-9A97-13AFF20EF4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962433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D267C2-1D8A-4BDC-8B53-FE6C81392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C216B57-66F9-48E5-A945-1F6E0F8CD9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E0226F9-F9D1-4013-AF15-AB22260F63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0BA2296-0AEB-466A-A095-9737D5739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C2670AF-8346-4785-94A2-0C2285B456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01689C7-15EE-4451-AECB-5A7AD4E41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3001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8852802-8C6E-4C53-90CE-D8E14006B2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6CC0EF80-D71D-4458-B2DE-A29F50A94A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D7338C4-15BA-48FD-88C6-1B20874144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53DDE45-992F-4D39-9F8D-7FB122BC45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87D0E1C-D550-459B-B809-7A1557DF2C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B993D39-9A10-44E2-BE27-82A61429D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33538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227C094-12B4-4337-8456-FE5FF63F6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5E9BA9E-86A6-4D00-A286-9EAEB17354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9D368D0-55B9-4BF8-91A8-D068A6AE55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8C8E5A-4F41-43A7-B2C1-F3D728A4D82F}" type="datetimeFigureOut">
              <a:rPr lang="it-IT" smtClean="0"/>
              <a:t>24/07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7095BD8-C8FB-4AEB-B7AF-8A13BB9AC0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E52748-A18A-40CF-8EFB-1AADF0286F0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51DCEC-681B-400F-BBAC-DD7D906E40A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1169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8" name="Immagine 407">
            <a:extLst>
              <a:ext uri="{FF2B5EF4-FFF2-40B4-BE49-F238E27FC236}">
                <a16:creationId xmlns:a16="http://schemas.microsoft.com/office/drawing/2014/main" id="{937B3BA8-ADD1-4062-86EB-EF25F48954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59335" y="0"/>
            <a:ext cx="7065876" cy="5535648"/>
          </a:xfrm>
          <a:prstGeom prst="rect">
            <a:avLst/>
          </a:prstGeom>
        </p:spPr>
      </p:pic>
      <p:sp>
        <p:nvSpPr>
          <p:cNvPr id="409" name="CasellaDiTesto 408">
            <a:extLst>
              <a:ext uri="{FF2B5EF4-FFF2-40B4-BE49-F238E27FC236}">
                <a16:creationId xmlns:a16="http://schemas.microsoft.com/office/drawing/2014/main" id="{3C18D84D-F68D-426A-B59D-88A667E63165}"/>
              </a:ext>
            </a:extLst>
          </p:cNvPr>
          <p:cNvSpPr txBox="1"/>
          <p:nvPr/>
        </p:nvSpPr>
        <p:spPr>
          <a:xfrm>
            <a:off x="1935821" y="0"/>
            <a:ext cx="4235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b="1" dirty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22C70051-1411-4267-A098-22DF49846BE3}"/>
              </a:ext>
            </a:extLst>
          </p:cNvPr>
          <p:cNvSpPr txBox="1"/>
          <p:nvPr/>
        </p:nvSpPr>
        <p:spPr>
          <a:xfrm>
            <a:off x="350786" y="5731958"/>
            <a:ext cx="1149042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/>
              <a:t>Fig. 1S A) TIC of </a:t>
            </a:r>
            <a:r>
              <a:rPr lang="it-IT" sz="1600" dirty="0" err="1"/>
              <a:t>six</a:t>
            </a:r>
            <a:r>
              <a:rPr lang="it-IT" sz="1600" dirty="0"/>
              <a:t> </a:t>
            </a:r>
            <a:r>
              <a:rPr lang="it-IT" sz="1600" dirty="0" err="1"/>
              <a:t>polyphenols</a:t>
            </a:r>
            <a:r>
              <a:rPr lang="it-IT" sz="1600" dirty="0"/>
              <a:t> and the </a:t>
            </a:r>
            <a:r>
              <a:rPr lang="it-IT" sz="1600" dirty="0" err="1"/>
              <a:t>AVNs</a:t>
            </a:r>
            <a:r>
              <a:rPr lang="it-IT" sz="1600" dirty="0"/>
              <a:t>. MS/MS </a:t>
            </a:r>
            <a:r>
              <a:rPr lang="it-IT" sz="1600" dirty="0" err="1"/>
              <a:t>spectra</a:t>
            </a:r>
            <a:r>
              <a:rPr lang="it-IT" sz="1600" dirty="0"/>
              <a:t> of B) </a:t>
            </a:r>
            <a:r>
              <a:rPr lang="it-IT" sz="1600" dirty="0" err="1"/>
              <a:t>Ferulic</a:t>
            </a:r>
            <a:r>
              <a:rPr lang="it-IT" sz="1600" dirty="0"/>
              <a:t> acid, C) </a:t>
            </a:r>
            <a:r>
              <a:rPr lang="it-IT" sz="1600" dirty="0" err="1"/>
              <a:t>Gallic</a:t>
            </a:r>
            <a:r>
              <a:rPr lang="it-IT" sz="1600" dirty="0"/>
              <a:t> acid, D) p-</a:t>
            </a:r>
            <a:r>
              <a:rPr lang="it-IT" sz="1600" dirty="0" err="1"/>
              <a:t>coumaric</a:t>
            </a:r>
            <a:r>
              <a:rPr lang="it-IT" sz="1600" dirty="0"/>
              <a:t> acid, E) </a:t>
            </a:r>
            <a:r>
              <a:rPr lang="it-IT" sz="1600" dirty="0" err="1"/>
              <a:t>Caffeic</a:t>
            </a:r>
            <a:r>
              <a:rPr lang="it-IT" sz="1600" dirty="0"/>
              <a:t> acid, F)</a:t>
            </a:r>
            <a:r>
              <a:rPr lang="it-IT" sz="1600" dirty="0" err="1"/>
              <a:t>Cinnamic</a:t>
            </a:r>
            <a:r>
              <a:rPr lang="it-IT" sz="1600" dirty="0"/>
              <a:t> acid,  G) </a:t>
            </a:r>
            <a:r>
              <a:rPr lang="it-IT" sz="1600" dirty="0" err="1"/>
              <a:t>Vanillic</a:t>
            </a:r>
            <a:r>
              <a:rPr lang="it-IT" sz="1600" dirty="0"/>
              <a:t> acid, H) AVN 2a, I)AVN 2b, J) AVN 2c.  </a:t>
            </a:r>
          </a:p>
        </p:txBody>
      </p:sp>
    </p:spTree>
    <p:extLst>
      <p:ext uri="{BB962C8B-B14F-4D97-AF65-F5344CB8AC3E}">
        <p14:creationId xmlns:p14="http://schemas.microsoft.com/office/powerpoint/2010/main" val="367539646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0" name="Immagine 819">
            <a:extLst>
              <a:ext uri="{FF2B5EF4-FFF2-40B4-BE49-F238E27FC236}">
                <a16:creationId xmlns:a16="http://schemas.microsoft.com/office/drawing/2014/main" id="{393B7840-FDE7-42D2-9EE1-4C0A5E7C203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827" y="189453"/>
            <a:ext cx="5543174" cy="4006594"/>
          </a:xfrm>
          <a:prstGeom prst="rect">
            <a:avLst/>
          </a:prstGeom>
        </p:spPr>
      </p:pic>
      <p:pic>
        <p:nvPicPr>
          <p:cNvPr id="1466" name="Immagine 1465">
            <a:extLst>
              <a:ext uri="{FF2B5EF4-FFF2-40B4-BE49-F238E27FC236}">
                <a16:creationId xmlns:a16="http://schemas.microsoft.com/office/drawing/2014/main" id="{347511B2-5D54-4CAC-A0F8-A5AA09332AE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1" y="189453"/>
            <a:ext cx="5940903" cy="4056326"/>
          </a:xfrm>
          <a:prstGeom prst="rect">
            <a:avLst/>
          </a:prstGeom>
        </p:spPr>
      </p:pic>
      <p:pic>
        <p:nvPicPr>
          <p:cNvPr id="1596" name="Immagine 1595">
            <a:extLst>
              <a:ext uri="{FF2B5EF4-FFF2-40B4-BE49-F238E27FC236}">
                <a16:creationId xmlns:a16="http://schemas.microsoft.com/office/drawing/2014/main" id="{33384CBA-B134-425A-AE55-B567FD50C6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827" y="4196047"/>
            <a:ext cx="5543174" cy="1954684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71004E44-A843-4020-A23F-B015916FA74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15000" y="4196047"/>
            <a:ext cx="5940903" cy="1954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78288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Immagine 105">
            <a:extLst>
              <a:ext uri="{FF2B5EF4-FFF2-40B4-BE49-F238E27FC236}">
                <a16:creationId xmlns:a16="http://schemas.microsoft.com/office/drawing/2014/main" id="{7529F31F-0B86-4EAE-87D0-D142D32E2A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816" y="238041"/>
            <a:ext cx="5110308" cy="2154345"/>
          </a:xfrm>
          <a:prstGeom prst="rect">
            <a:avLst/>
          </a:prstGeom>
        </p:spPr>
      </p:pic>
      <p:pic>
        <p:nvPicPr>
          <p:cNvPr id="488" name="Immagine 487">
            <a:extLst>
              <a:ext uri="{FF2B5EF4-FFF2-40B4-BE49-F238E27FC236}">
                <a16:creationId xmlns:a16="http://schemas.microsoft.com/office/drawing/2014/main" id="{50858D41-C958-4DB8-8E3C-A4ECE1A901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1278" y="2303143"/>
            <a:ext cx="5241384" cy="2154345"/>
          </a:xfrm>
          <a:prstGeom prst="rect">
            <a:avLst/>
          </a:prstGeom>
        </p:spPr>
      </p:pic>
      <p:pic>
        <p:nvPicPr>
          <p:cNvPr id="592" name="Immagine 591">
            <a:extLst>
              <a:ext uri="{FF2B5EF4-FFF2-40B4-BE49-F238E27FC236}">
                <a16:creationId xmlns:a16="http://schemas.microsoft.com/office/drawing/2014/main" id="{28A52E55-843B-4D63-BAA6-1E1B7D18A0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279" y="4457488"/>
            <a:ext cx="5241383" cy="21624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62146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5</Words>
  <Application>Microsoft Office PowerPoint</Application>
  <PresentationFormat>Widescreen</PresentationFormat>
  <Paragraphs>2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lda Aiello</dc:creator>
  <cp:lastModifiedBy>Gilda Aiello</cp:lastModifiedBy>
  <cp:revision>2</cp:revision>
  <dcterms:created xsi:type="dcterms:W3CDTF">2021-07-20T08:25:46Z</dcterms:created>
  <dcterms:modified xsi:type="dcterms:W3CDTF">2021-07-24T12:44:48Z</dcterms:modified>
</cp:coreProperties>
</file>